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9" r:id="rId4"/>
    <p:sldId id="260" r:id="rId5"/>
    <p:sldId id="261" r:id="rId6"/>
    <p:sldId id="262" r:id="rId7"/>
    <p:sldId id="263" r:id="rId8"/>
    <p:sldId id="264" r:id="rId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725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E6EE3A6-CF75-4A2E-9161-3F4AAEAA52E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AD6112C1-7E7E-461E-8A73-A4D893D53F9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4B023F5-9242-438B-989B-5E05815BD1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1FB05-F793-4FA0-BA99-955AD419B6E0}" type="datetimeFigureOut">
              <a:rPr lang="zh-CN" altLang="en-US" smtClean="0"/>
              <a:t>2022/6/2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E86D668-BDA9-4583-99B3-1721B1616D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3A46B21-8E16-46E2-88C0-CFABACE02F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94171-4E06-4AC1-B92E-95D962929D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54173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75EC9A5-24EE-41B9-AC7E-2EA5D5F3A2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15F36E8-289F-493F-B22A-C5EC091E5A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36DE42D-DFE1-42E1-A47E-83F5734213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1FB05-F793-4FA0-BA99-955AD419B6E0}" type="datetimeFigureOut">
              <a:rPr lang="zh-CN" altLang="en-US" smtClean="0"/>
              <a:t>2022/6/2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3C83E95-5FE6-4862-8178-88090DD33F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6F2E9BE-19A4-4A3D-8540-9952237C77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94171-4E06-4AC1-B92E-95D962929D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53276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0AFFC6EB-EB86-4A9F-8184-2F166B06E7D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5352D7E-5C31-459D-BA7D-9FBCF19B7B5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E212386-0E60-4597-971D-743FCFC900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1FB05-F793-4FA0-BA99-955AD419B6E0}" type="datetimeFigureOut">
              <a:rPr lang="zh-CN" altLang="en-US" smtClean="0"/>
              <a:t>2022/6/2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F73CFC9-5222-4CAD-8DFF-3288F2E216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B1F5022-C000-4C74-9CB1-034B59C4A4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94171-4E06-4AC1-B92E-95D962929D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935133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E7E4F51-E8E4-472F-8150-3C7540B18E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3233F67-075B-4C3A-B985-BC63C643AE2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A426A04-37C9-4485-8295-B229AC0AE5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1FB05-F793-4FA0-BA99-955AD419B6E0}" type="datetimeFigureOut">
              <a:rPr lang="zh-CN" altLang="en-US" smtClean="0"/>
              <a:t>2022/6/2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43F1F57-6EBA-45CD-81C6-22ABC36899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451C9CA-53D0-422C-9723-76D0104390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94171-4E06-4AC1-B92E-95D962929D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81102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B167B06-6B1E-4E75-858C-5DA2472D48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4F32715-00B5-43E3-9C2B-8CDEAA12B6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108B9C8-6CB9-476D-BE7F-FDBE78A61D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1FB05-F793-4FA0-BA99-955AD419B6E0}" type="datetimeFigureOut">
              <a:rPr lang="zh-CN" altLang="en-US" smtClean="0"/>
              <a:t>2022/6/2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D047281-1AA7-4EE3-A77E-1F1E02556A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5DC54F0-FD18-4092-8AD0-44A18763A4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94171-4E06-4AC1-B92E-95D962929D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87488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D9857F3-8555-4FB5-8793-6FC2ED9AE8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F9DB5EC-F640-40C1-BF08-4FA9C5F5836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95839BE-16C6-4BF1-B0F5-0CBAB1515DE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BB5D24A-0D2F-42A8-A558-52ADBCB6C1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1FB05-F793-4FA0-BA99-955AD419B6E0}" type="datetimeFigureOut">
              <a:rPr lang="zh-CN" altLang="en-US" smtClean="0"/>
              <a:t>2022/6/2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91EF9B9-A873-4631-BD7A-26DC06D3CD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BE8A79F-3A48-4F7F-AC24-96E3703CC9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94171-4E06-4AC1-B92E-95D962929D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80339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CD07714-C435-4AF9-974E-3B7AA9A553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B6BF4C0-066D-4E6E-8E79-823D79E242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5AAA969-F10E-466E-9178-FFE23CFA00C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721E0141-2E14-4025-8398-042DD77C9E7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A549996D-EDA0-4C45-B18F-6F7F268F3BB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FF872B95-C624-435E-8A39-954E044332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1FB05-F793-4FA0-BA99-955AD419B6E0}" type="datetimeFigureOut">
              <a:rPr lang="zh-CN" altLang="en-US" smtClean="0"/>
              <a:t>2022/6/20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06F16FE8-2082-4E0C-B3D8-411C8D1E9C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01E011A2-B083-419F-9D66-F44DDFEE02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94171-4E06-4AC1-B92E-95D962929D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05408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D41EA68-1252-40ED-8090-26918B67ED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E796AB5-A187-4992-9AD0-52F4D62D1B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1FB05-F793-4FA0-BA99-955AD419B6E0}" type="datetimeFigureOut">
              <a:rPr lang="zh-CN" altLang="en-US" smtClean="0"/>
              <a:t>2022/6/20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EBAEBF85-80BA-4E26-854F-CB8F878C69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ED69AA61-2D62-4410-8265-0996FBB9E6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94171-4E06-4AC1-B92E-95D962929D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23584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69038C68-A9B0-4269-B70B-16370D1805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1FB05-F793-4FA0-BA99-955AD419B6E0}" type="datetimeFigureOut">
              <a:rPr lang="zh-CN" altLang="en-US" smtClean="0"/>
              <a:t>2022/6/20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A39B3451-19BB-4DB1-9A81-D486364CB7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77081D1D-5259-4F46-A44A-ED962CBDDC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94171-4E06-4AC1-B92E-95D962929D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49660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26DB224-24B7-4CE9-A218-07F973E7B1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4C55730-9731-413C-A6D7-42EEF05D885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A5CEB3C-087E-489A-BB30-B9CC589FFE5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EA11E75-B624-44FE-AFE9-3FF5CD9FCC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1FB05-F793-4FA0-BA99-955AD419B6E0}" type="datetimeFigureOut">
              <a:rPr lang="zh-CN" altLang="en-US" smtClean="0"/>
              <a:t>2022/6/2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AA4B5E5-3E54-489C-8CB0-8FA74997D8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D426122-DEA0-42FA-8D91-2988A7610A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94171-4E06-4AC1-B92E-95D962929D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56555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D78BB38-4BAB-41AD-805D-65146E1D50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8D6FF13D-A3F7-4DD5-8F2A-F00378B79FD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38B3FED-4885-4090-B64A-0F9687D09D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B5D81E7-5BC2-4043-8BD2-9B7956D133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1FB05-F793-4FA0-BA99-955AD419B6E0}" type="datetimeFigureOut">
              <a:rPr lang="zh-CN" altLang="en-US" smtClean="0"/>
              <a:t>2022/6/2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90BF5F8-820B-41BF-ABD2-7382083ADC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EEC95C7-5E95-4D63-9EC0-BA9BB42031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94171-4E06-4AC1-B92E-95D962929D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387560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62ADA65E-E9DC-4F2D-AC75-388B26167E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176EA8E-468C-433F-BCC2-B0D528E93D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02BCF29-9B04-4658-9589-F43116DBF39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91FB05-F793-4FA0-BA99-955AD419B6E0}" type="datetimeFigureOut">
              <a:rPr lang="zh-CN" altLang="en-US" smtClean="0"/>
              <a:t>2022/6/2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71E1057-6A46-4FC3-B55D-7AA0F7A9513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1A1C00A-992D-40D5-AD24-BB188E3ABA5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494171-4E06-4AC1-B92E-95D962929D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35342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3AAA927-130E-4CA0-8945-F6F50282B290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altLang="zh-CN" b="1" dirty="0"/>
              <a:t>Original western blots</a:t>
            </a:r>
            <a:endParaRPr lang="zh-CN" altLang="en-US" b="1" dirty="0"/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04AD4C90-57CD-42E9-BC03-AF510092F3D7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 altLang="zh-CN" b="1" dirty="0"/>
          </a:p>
          <a:p>
            <a:r>
              <a:rPr lang="en-US" altLang="zh-CN" b="1" dirty="0"/>
              <a:t>(Supplemental Material)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3593187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E024277-4819-43FF-90AB-4DC054AF67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/>
              <a:t>Figure 2J</a:t>
            </a:r>
            <a:endParaRPr lang="zh-CN" altLang="en-US" dirty="0"/>
          </a:p>
        </p:txBody>
      </p:sp>
      <p:pic>
        <p:nvPicPr>
          <p:cNvPr id="13" name="内容占位符 12">
            <a:extLst>
              <a:ext uri="{FF2B5EF4-FFF2-40B4-BE49-F238E27FC236}">
                <a16:creationId xmlns:a16="http://schemas.microsoft.com/office/drawing/2014/main" id="{325C40D3-5847-47A9-9B44-D6D924DA9D6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10100" y="2204244"/>
            <a:ext cx="2971800" cy="3594100"/>
          </a:xfrm>
        </p:spPr>
      </p:pic>
    </p:spTree>
    <p:extLst>
      <p:ext uri="{BB962C8B-B14F-4D97-AF65-F5344CB8AC3E}">
        <p14:creationId xmlns:p14="http://schemas.microsoft.com/office/powerpoint/2010/main" val="30375564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0930264-8D10-4246-8E20-93B5C64854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/>
              <a:t>Figure 3E</a:t>
            </a:r>
            <a:endParaRPr lang="zh-CN" altLang="en-US" dirty="0"/>
          </a:p>
        </p:txBody>
      </p:sp>
      <p:sp>
        <p:nvSpPr>
          <p:cNvPr id="15" name="内容占位符 14">
            <a:extLst>
              <a:ext uri="{FF2B5EF4-FFF2-40B4-BE49-F238E27FC236}">
                <a16:creationId xmlns:a16="http://schemas.microsoft.com/office/drawing/2014/main" id="{477C0DBE-A249-43E5-BC93-53FDF455DC0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 altLang="zh-CN" dirty="0"/>
          </a:p>
          <a:p>
            <a:pPr marL="0" indent="0">
              <a:buNone/>
            </a:pPr>
            <a:endParaRPr lang="zh-CN" altLang="en-US" dirty="0"/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9682566A-8A52-4597-9B83-FADDE8FCF1A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19487" y="2038350"/>
            <a:ext cx="5153025" cy="2781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019949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9321022-5902-4967-9F2A-5F86D0E025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/>
              <a:t>Figure 3F</a:t>
            </a:r>
            <a:endParaRPr lang="zh-CN" altLang="en-US" dirty="0"/>
          </a:p>
        </p:txBody>
      </p:sp>
      <p:pic>
        <p:nvPicPr>
          <p:cNvPr id="5" name="内容占位符 4">
            <a:extLst>
              <a:ext uri="{FF2B5EF4-FFF2-40B4-BE49-F238E27FC236}">
                <a16:creationId xmlns:a16="http://schemas.microsoft.com/office/drawing/2014/main" id="{5DD11DDF-BDC2-4E10-9C94-B8AF020E001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69128" y="2143471"/>
            <a:ext cx="3266584" cy="3997267"/>
          </a:xfrm>
        </p:spPr>
      </p:pic>
    </p:spTree>
    <p:extLst>
      <p:ext uri="{BB962C8B-B14F-4D97-AF65-F5344CB8AC3E}">
        <p14:creationId xmlns:p14="http://schemas.microsoft.com/office/powerpoint/2010/main" val="65743530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08CA612-1690-49E3-A7A9-0071EBE0B2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/>
              <a:t>Figure 3G</a:t>
            </a:r>
            <a:endParaRPr lang="zh-CN" altLang="en-US" dirty="0"/>
          </a:p>
        </p:txBody>
      </p:sp>
      <p:pic>
        <p:nvPicPr>
          <p:cNvPr id="9" name="内容占位符 8">
            <a:extLst>
              <a:ext uri="{FF2B5EF4-FFF2-40B4-BE49-F238E27FC236}">
                <a16:creationId xmlns:a16="http://schemas.microsoft.com/office/drawing/2014/main" id="{8135A238-CFDB-4083-A38D-644C7B34DE38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37932" y="1825625"/>
            <a:ext cx="2516136" cy="4351338"/>
          </a:xfrm>
        </p:spPr>
      </p:pic>
    </p:spTree>
    <p:extLst>
      <p:ext uri="{BB962C8B-B14F-4D97-AF65-F5344CB8AC3E}">
        <p14:creationId xmlns:p14="http://schemas.microsoft.com/office/powerpoint/2010/main" val="389557937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52416B6-4355-4956-99F3-4B269B92FA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/>
              <a:t>Figure 4B</a:t>
            </a:r>
            <a:endParaRPr lang="zh-CN" altLang="en-US" dirty="0"/>
          </a:p>
        </p:txBody>
      </p:sp>
      <p:pic>
        <p:nvPicPr>
          <p:cNvPr id="5" name="内容占位符 4">
            <a:extLst>
              <a:ext uri="{FF2B5EF4-FFF2-40B4-BE49-F238E27FC236}">
                <a16:creationId xmlns:a16="http://schemas.microsoft.com/office/drawing/2014/main" id="{959305A6-5AD4-4179-B42E-38352F98E80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25930" y="1825625"/>
            <a:ext cx="3140140" cy="4351338"/>
          </a:xfrm>
        </p:spPr>
      </p:pic>
    </p:spTree>
    <p:extLst>
      <p:ext uri="{BB962C8B-B14F-4D97-AF65-F5344CB8AC3E}">
        <p14:creationId xmlns:p14="http://schemas.microsoft.com/office/powerpoint/2010/main" val="183123614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103BA40-FF0A-4897-A6A7-306DABE484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/>
              <a:t>Figure 4E</a:t>
            </a:r>
            <a:endParaRPr lang="zh-CN" altLang="en-US" dirty="0"/>
          </a:p>
        </p:txBody>
      </p:sp>
      <p:pic>
        <p:nvPicPr>
          <p:cNvPr id="13" name="内容占位符 12">
            <a:extLst>
              <a:ext uri="{FF2B5EF4-FFF2-40B4-BE49-F238E27FC236}">
                <a16:creationId xmlns:a16="http://schemas.microsoft.com/office/drawing/2014/main" id="{C1F9F154-9AC7-43C3-BB5A-A81633A20004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61581" y="1825625"/>
            <a:ext cx="2868838" cy="4351338"/>
          </a:xfrm>
        </p:spPr>
      </p:pic>
    </p:spTree>
    <p:extLst>
      <p:ext uri="{BB962C8B-B14F-4D97-AF65-F5344CB8AC3E}">
        <p14:creationId xmlns:p14="http://schemas.microsoft.com/office/powerpoint/2010/main" val="404534753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85A1788-A454-463D-A7E1-FAC6ABD16F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/>
              <a:t>Figure 8C</a:t>
            </a:r>
            <a:endParaRPr lang="zh-CN" altLang="en-US" dirty="0"/>
          </a:p>
        </p:txBody>
      </p:sp>
      <p:pic>
        <p:nvPicPr>
          <p:cNvPr id="5" name="内容占位符 4">
            <a:extLst>
              <a:ext uri="{FF2B5EF4-FFF2-40B4-BE49-F238E27FC236}">
                <a16:creationId xmlns:a16="http://schemas.microsoft.com/office/drawing/2014/main" id="{DA9DB8AD-83CB-40F2-912C-8E5336330208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26255" y="1825625"/>
            <a:ext cx="7739489" cy="4351338"/>
          </a:xfrm>
        </p:spPr>
      </p:pic>
    </p:spTree>
    <p:extLst>
      <p:ext uri="{BB962C8B-B14F-4D97-AF65-F5344CB8AC3E}">
        <p14:creationId xmlns:p14="http://schemas.microsoft.com/office/powerpoint/2010/main" val="26741232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9</TotalTime>
  <Words>21</Words>
  <Application>Microsoft Office PowerPoint</Application>
  <PresentationFormat>宽屏</PresentationFormat>
  <Paragraphs>10</Paragraphs>
  <Slides>8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2" baseType="lpstr">
      <vt:lpstr>等线</vt:lpstr>
      <vt:lpstr>等线 Light</vt:lpstr>
      <vt:lpstr>Arial</vt:lpstr>
      <vt:lpstr>Office 主题​​</vt:lpstr>
      <vt:lpstr>Original western blots</vt:lpstr>
      <vt:lpstr>Figure 2J</vt:lpstr>
      <vt:lpstr>Figure 3E</vt:lpstr>
      <vt:lpstr>Figure 3F</vt:lpstr>
      <vt:lpstr>Figure 3G</vt:lpstr>
      <vt:lpstr>Figure 4B</vt:lpstr>
      <vt:lpstr>Figure 4E</vt:lpstr>
      <vt:lpstr>Figure 8C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Original western blots</dc:title>
  <dc:creator>熊 劲节</dc:creator>
  <cp:lastModifiedBy>熊 劲节</cp:lastModifiedBy>
  <cp:revision>19</cp:revision>
  <dcterms:created xsi:type="dcterms:W3CDTF">2022-06-18T06:59:13Z</dcterms:created>
  <dcterms:modified xsi:type="dcterms:W3CDTF">2022-06-20T13:23:13Z</dcterms:modified>
</cp:coreProperties>
</file>